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440021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325" autoAdjust="0"/>
  </p:normalViewPr>
  <p:slideViewPr>
    <p:cSldViewPr snapToGrid="0">
      <p:cViewPr>
        <p:scale>
          <a:sx n="33" d="100"/>
          <a:sy n="33" d="100"/>
        </p:scale>
        <p:origin x="1628" y="-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BC935A-1C73-44E0-A690-D105D4D972C7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5E566F-0B50-468A-A818-93A89A4582E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9327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5E566F-0B50-468A-A818-93A89A4582ED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30555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356703"/>
            <a:ext cx="12240181" cy="501340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7563446"/>
            <a:ext cx="10800160" cy="3476717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6024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4205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766678"/>
            <a:ext cx="3105046" cy="1220351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766678"/>
            <a:ext cx="9135135" cy="12203515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78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9091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3590057"/>
            <a:ext cx="12420184" cy="5990088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9636813"/>
            <a:ext cx="12420184" cy="3150046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5652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3833390"/>
            <a:ext cx="6120091" cy="913680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3833390"/>
            <a:ext cx="6120091" cy="913680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93301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66681"/>
            <a:ext cx="12420184" cy="2783376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3530053"/>
            <a:ext cx="6091964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5260078"/>
            <a:ext cx="6091964" cy="773678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3530053"/>
            <a:ext cx="6121966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5260078"/>
            <a:ext cx="6121966" cy="773678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2026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3020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4624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073367"/>
            <a:ext cx="7290108" cy="10233485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5963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073367"/>
            <a:ext cx="7290108" cy="10233485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1757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766681"/>
            <a:ext cx="12420184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3833390"/>
            <a:ext cx="12420184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400724-7FB5-4E1A-AC61-0A153D56B72A}" type="datetimeFigureOut">
              <a:rPr lang="fr-FR" smtClean="0"/>
              <a:t>16/06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3346867"/>
            <a:ext cx="4860072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7BCD5D-59C5-4554-B128-762AACEECD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2833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656" y="603118"/>
            <a:ext cx="13247649" cy="13247649"/>
          </a:xfrm>
          <a:prstGeom prst="rect">
            <a:avLst/>
          </a:prstGeom>
          <a:ln w="31750">
            <a:noFill/>
          </a:ln>
        </p:spPr>
      </p:pic>
      <p:sp>
        <p:nvSpPr>
          <p:cNvPr id="5" name="ZoneTexte 4"/>
          <p:cNvSpPr txBox="1"/>
          <p:nvPr/>
        </p:nvSpPr>
        <p:spPr>
          <a:xfrm>
            <a:off x="1614794" y="13614229"/>
            <a:ext cx="110789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S02.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ircos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lot of the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roportions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f metabolite-associated SNPs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outer track, in red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etabolite-associated genes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inner track, in green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long the sunflower genome chromosomes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ach sector corresponds to a different chromosome, whose coordinates are shown on the x-axis. The proportions of metabolite-associated SNPs and genes, instead, are indicated on the y-axis. Both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f the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roportions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ere calculated using a sliding-window approach; the window length was set at 5 Mb and the pass of its incremental advance at 1 Mb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he approximate position of the six identified hot spots are indicated by blue boxes numbered from 1 to 6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ot spots were defined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pplying to each window a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reshold based on the proportion and on the absolute number of metabolite-associated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genes found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 each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indow itself.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rapèze 5"/>
          <p:cNvSpPr/>
          <p:nvPr/>
        </p:nvSpPr>
        <p:spPr>
          <a:xfrm rot="1260000">
            <a:off x="5276501" y="9687367"/>
            <a:ext cx="516467" cy="3419577"/>
          </a:xfrm>
          <a:prstGeom prst="trapezoid">
            <a:avLst/>
          </a:prstGeom>
          <a:noFill/>
          <a:ln w="317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Trapèze 6"/>
          <p:cNvSpPr/>
          <p:nvPr/>
        </p:nvSpPr>
        <p:spPr>
          <a:xfrm rot="660000">
            <a:off x="6025800" y="9903267"/>
            <a:ext cx="516467" cy="3419577"/>
          </a:xfrm>
          <a:prstGeom prst="trapezoid">
            <a:avLst/>
          </a:prstGeom>
          <a:noFill/>
          <a:ln w="317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Trapèze 7"/>
          <p:cNvSpPr/>
          <p:nvPr/>
        </p:nvSpPr>
        <p:spPr>
          <a:xfrm rot="2460000">
            <a:off x="4014968" y="8959246"/>
            <a:ext cx="516467" cy="3419577"/>
          </a:xfrm>
          <a:prstGeom prst="trapezoid">
            <a:avLst/>
          </a:prstGeom>
          <a:noFill/>
          <a:ln w="317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Trapèze 8"/>
          <p:cNvSpPr/>
          <p:nvPr/>
        </p:nvSpPr>
        <p:spPr>
          <a:xfrm rot="3960000">
            <a:off x="2685904" y="7346862"/>
            <a:ext cx="814790" cy="3419577"/>
          </a:xfrm>
          <a:prstGeom prst="trapezoid">
            <a:avLst/>
          </a:prstGeom>
          <a:noFill/>
          <a:ln w="317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rapèze 9"/>
          <p:cNvSpPr/>
          <p:nvPr/>
        </p:nvSpPr>
        <p:spPr>
          <a:xfrm rot="14280000">
            <a:off x="10563234" y="3182870"/>
            <a:ext cx="814790" cy="3419577"/>
          </a:xfrm>
          <a:prstGeom prst="trapezoid">
            <a:avLst/>
          </a:prstGeom>
          <a:noFill/>
          <a:ln w="317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Trapèze 10"/>
          <p:cNvSpPr/>
          <p:nvPr/>
        </p:nvSpPr>
        <p:spPr>
          <a:xfrm rot="8460000">
            <a:off x="4137035" y="1981961"/>
            <a:ext cx="814790" cy="3419577"/>
          </a:xfrm>
          <a:prstGeom prst="trapezoid">
            <a:avLst/>
          </a:prstGeom>
          <a:noFill/>
          <a:ln w="317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Ellipse 11"/>
          <p:cNvSpPr>
            <a:spLocks noChangeAspect="1"/>
          </p:cNvSpPr>
          <p:nvPr/>
        </p:nvSpPr>
        <p:spPr>
          <a:xfrm>
            <a:off x="6501078" y="9422728"/>
            <a:ext cx="365760" cy="365760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Ellipse 13"/>
          <p:cNvSpPr>
            <a:spLocks noChangeAspect="1"/>
          </p:cNvSpPr>
          <p:nvPr/>
        </p:nvSpPr>
        <p:spPr>
          <a:xfrm>
            <a:off x="6079054" y="9322553"/>
            <a:ext cx="365760" cy="365760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" name="Ellipse 14"/>
          <p:cNvSpPr>
            <a:spLocks noChangeAspect="1"/>
          </p:cNvSpPr>
          <p:nvPr/>
        </p:nvSpPr>
        <p:spPr>
          <a:xfrm>
            <a:off x="5439799" y="8959835"/>
            <a:ext cx="365760" cy="365760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Ellipse 15"/>
          <p:cNvSpPr>
            <a:spLocks noChangeAspect="1"/>
          </p:cNvSpPr>
          <p:nvPr/>
        </p:nvSpPr>
        <p:spPr>
          <a:xfrm>
            <a:off x="4764625" y="8069265"/>
            <a:ext cx="365760" cy="365760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Ellipse 16"/>
          <p:cNvSpPr>
            <a:spLocks noChangeAspect="1"/>
          </p:cNvSpPr>
          <p:nvPr/>
        </p:nvSpPr>
        <p:spPr>
          <a:xfrm>
            <a:off x="5631048" y="5094007"/>
            <a:ext cx="365760" cy="365760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8" name="Ellipse 17"/>
          <p:cNvSpPr>
            <a:spLocks noChangeAspect="1"/>
          </p:cNvSpPr>
          <p:nvPr/>
        </p:nvSpPr>
        <p:spPr>
          <a:xfrm>
            <a:off x="8976684" y="5775584"/>
            <a:ext cx="365760" cy="365760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2930823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153</Words>
  <Application>Microsoft Office PowerPoint</Application>
  <PresentationFormat>Personnalisé</PresentationFormat>
  <Paragraphs>8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o Moroldo</dc:creator>
  <cp:lastModifiedBy>Marco Moroldo</cp:lastModifiedBy>
  <cp:revision>16</cp:revision>
  <dcterms:created xsi:type="dcterms:W3CDTF">2023-06-13T13:05:59Z</dcterms:created>
  <dcterms:modified xsi:type="dcterms:W3CDTF">2023-06-16T13:25:44Z</dcterms:modified>
</cp:coreProperties>
</file>